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7772400" cy="100584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-2016" y="-12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45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10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10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7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76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84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94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11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9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424314" y="1747030"/>
            <a:ext cx="4939416" cy="387300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68161" y="5733534"/>
            <a:ext cx="5375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ing OS in patients with high (&gt; 500) and low (&lt; 500) serum AFP.  Log-rank test demonstrated no significant association between OS and serum AFP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1163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6</TotalTime>
  <Words>41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g55</dc:creator>
  <cp:lastModifiedBy>Ryan T</cp:lastModifiedBy>
  <cp:revision>23</cp:revision>
  <cp:lastPrinted>2015-04-23T21:25:43Z</cp:lastPrinted>
  <dcterms:created xsi:type="dcterms:W3CDTF">2015-04-23T20:59:46Z</dcterms:created>
  <dcterms:modified xsi:type="dcterms:W3CDTF">2015-05-29T02:09:31Z</dcterms:modified>
</cp:coreProperties>
</file>